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8" r:id="rId2"/>
    <p:sldId id="270" r:id="rId3"/>
    <p:sldId id="26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842" userDrawn="1">
          <p15:clr>
            <a:srgbClr val="A4A3A4"/>
          </p15:clr>
        </p15:guide>
        <p15:guide id="2" pos="4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56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2196" y="708"/>
      </p:cViewPr>
      <p:guideLst>
        <p:guide orient="horz" pos="5842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094B4D-09DA-474D-AF02-31A7810D8E1D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2DF4B8-48B3-425C-B4D5-2240CAEB5A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716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6463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1348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005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3950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6776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5195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91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784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3807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2296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5171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2AC1C-E484-4974-BB00-C74C241605C5}" type="datetimeFigureOut">
              <a:rPr lang="zh-CN" altLang="en-US" smtClean="0"/>
              <a:t>2024/7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716AA-13A3-4459-8777-A7A6A7EA51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7983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4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microsoft.com/office/2007/relationships/hdphoto" Target="../media/hdphoto2.wdp"/><Relationship Id="rId4" Type="http://schemas.openxmlformats.org/officeDocument/2006/relationships/image" Target="../media/image16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23.emf"/><Relationship Id="rId4" Type="http://schemas.openxmlformats.org/officeDocument/2006/relationships/image" Target="../media/image20.emf"/><Relationship Id="rId9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78AC5667-054A-A372-6F4F-3248573B47E5}"/>
              </a:ext>
            </a:extLst>
          </p:cNvPr>
          <p:cNvSpPr txBox="1"/>
          <p:nvPr/>
        </p:nvSpPr>
        <p:spPr>
          <a:xfrm>
            <a:off x="201531" y="344583"/>
            <a:ext cx="1435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CFF91F06-EC46-0C59-4D5A-5A5C31CCB3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7730263"/>
              </p:ext>
            </p:extLst>
          </p:nvPr>
        </p:nvGraphicFramePr>
        <p:xfrm>
          <a:off x="666173" y="5218248"/>
          <a:ext cx="2749550" cy="2424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748916" imgH="2424197" progId="Prism9.Document">
                  <p:embed/>
                </p:oleObj>
              </mc:Choice>
              <mc:Fallback>
                <p:oleObj name="Prism 9" r:id="rId2" imgW="2748916" imgH="242419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66173" y="5218248"/>
                        <a:ext cx="2749550" cy="2424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4">
            <a:extLst>
              <a:ext uri="{FF2B5EF4-FFF2-40B4-BE49-F238E27FC236}">
                <a16:creationId xmlns:a16="http://schemas.microsoft.com/office/drawing/2014/main" id="{F48B1855-AF8F-3004-BCBF-BA6A0F3790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821" y="2101392"/>
            <a:ext cx="8605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Normal</a:t>
            </a:r>
            <a:endParaRPr lang="zh-CN" altLang="en-US" sz="1000" b="1" dirty="0"/>
          </a:p>
        </p:txBody>
      </p:sp>
      <p:sp>
        <p:nvSpPr>
          <p:cNvPr id="9" name="TextBox 4">
            <a:extLst>
              <a:ext uri="{FF2B5EF4-FFF2-40B4-BE49-F238E27FC236}">
                <a16:creationId xmlns:a16="http://schemas.microsoft.com/office/drawing/2014/main" id="{E778EC58-C6E6-737C-7DA1-0105A1E6BF5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821" y="3562538"/>
            <a:ext cx="8605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Tumor</a:t>
            </a:r>
            <a:endParaRPr lang="zh-CN" altLang="en-US" sz="1000" b="1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0317EAE4-3BBD-F6C4-9420-AE9F6F15B86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7516" y="1812552"/>
            <a:ext cx="479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20 X</a:t>
            </a:r>
            <a:endParaRPr lang="zh-CN" altLang="en-US" sz="1000" b="1" dirty="0"/>
          </a:p>
        </p:txBody>
      </p:sp>
      <p:sp>
        <p:nvSpPr>
          <p:cNvPr id="11" name="TextBox 4">
            <a:extLst>
              <a:ext uri="{FF2B5EF4-FFF2-40B4-BE49-F238E27FC236}">
                <a16:creationId xmlns:a16="http://schemas.microsoft.com/office/drawing/2014/main" id="{EB55177C-0A0D-EF3B-BE4D-1645F4A722D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7516" y="2528308"/>
            <a:ext cx="479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63 X</a:t>
            </a:r>
            <a:endParaRPr lang="zh-CN" altLang="en-US" sz="1000" b="1" dirty="0"/>
          </a:p>
        </p:txBody>
      </p:sp>
      <p:sp>
        <p:nvSpPr>
          <p:cNvPr id="12" name="TextBox 4">
            <a:extLst>
              <a:ext uri="{FF2B5EF4-FFF2-40B4-BE49-F238E27FC236}">
                <a16:creationId xmlns:a16="http://schemas.microsoft.com/office/drawing/2014/main" id="{AAB61D3A-CF54-0021-6527-FF19159E3CA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7517" y="3411705"/>
            <a:ext cx="479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20 X</a:t>
            </a:r>
            <a:endParaRPr lang="zh-CN" altLang="en-US" sz="1000" b="1" dirty="0"/>
          </a:p>
        </p:txBody>
      </p:sp>
      <p:sp>
        <p:nvSpPr>
          <p:cNvPr id="13" name="TextBox 4">
            <a:extLst>
              <a:ext uri="{FF2B5EF4-FFF2-40B4-BE49-F238E27FC236}">
                <a16:creationId xmlns:a16="http://schemas.microsoft.com/office/drawing/2014/main" id="{DE888B0C-B5AF-5C85-FCE7-2E7A80AED4B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67517" y="4089361"/>
            <a:ext cx="47958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63 X</a:t>
            </a:r>
            <a:endParaRPr lang="zh-CN" altLang="en-US" sz="1000" b="1" dirty="0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58925964-6194-ED11-429B-8CE23A2F371F}"/>
              </a:ext>
            </a:extLst>
          </p:cNvPr>
          <p:cNvCxnSpPr>
            <a:cxnSpLocks/>
          </p:cNvCxnSpPr>
          <p:nvPr/>
        </p:nvCxnSpPr>
        <p:spPr>
          <a:xfrm>
            <a:off x="589478" y="1579423"/>
            <a:ext cx="0" cy="14779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2C4BA52B-975A-D2FD-A3BA-FC66C66F9746}"/>
              </a:ext>
            </a:extLst>
          </p:cNvPr>
          <p:cNvCxnSpPr>
            <a:cxnSpLocks/>
          </p:cNvCxnSpPr>
          <p:nvPr/>
        </p:nvCxnSpPr>
        <p:spPr>
          <a:xfrm>
            <a:off x="589478" y="3261369"/>
            <a:ext cx="0" cy="14779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4">
            <a:extLst>
              <a:ext uri="{FF2B5EF4-FFF2-40B4-BE49-F238E27FC236}">
                <a16:creationId xmlns:a16="http://schemas.microsoft.com/office/drawing/2014/main" id="{B8AA19FF-A8BD-E5EB-F4E6-F5EEB03F43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23196" y="1263674"/>
            <a:ext cx="8605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Case #1</a:t>
            </a:r>
            <a:endParaRPr lang="zh-CN" altLang="en-US" sz="1000" b="1" dirty="0"/>
          </a:p>
        </p:txBody>
      </p:sp>
      <p:sp>
        <p:nvSpPr>
          <p:cNvPr id="17" name="TextBox 4">
            <a:extLst>
              <a:ext uri="{FF2B5EF4-FFF2-40B4-BE49-F238E27FC236}">
                <a16:creationId xmlns:a16="http://schemas.microsoft.com/office/drawing/2014/main" id="{7AE29242-778F-4E20-D220-0A3EBAE759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1077" y="1263674"/>
            <a:ext cx="8605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Case #2</a:t>
            </a:r>
            <a:endParaRPr lang="zh-CN" altLang="en-US" sz="1000" b="1" dirty="0"/>
          </a:p>
        </p:txBody>
      </p:sp>
      <p:sp>
        <p:nvSpPr>
          <p:cNvPr id="18" name="TextBox 4">
            <a:extLst>
              <a:ext uri="{FF2B5EF4-FFF2-40B4-BE49-F238E27FC236}">
                <a16:creationId xmlns:a16="http://schemas.microsoft.com/office/drawing/2014/main" id="{844A5603-8C1B-7D7F-5B8F-8D3D7F37DA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8478" y="1263674"/>
            <a:ext cx="8605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b="1" dirty="0"/>
              <a:t>Case #3</a:t>
            </a:r>
            <a:endParaRPr lang="zh-CN" altLang="en-US" sz="1000" b="1" dirty="0"/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60917F16-CC96-CE59-CDD7-477AA8F619B2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7978" y="2298385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D5250BFA-B23E-E3FE-436D-466FAA41F12F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7978" y="1513687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ECC14A4-3F9D-8DF6-5D80-D20609FF828C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7978" y="3932380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F82F2070-1AF5-6183-F5AB-E062596DB35E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77978" y="3143298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AD4DD328-4F6C-1E99-811D-FCC93AB86AB1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0948" y="2298385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9D39B6C1-D732-AA2C-AB51-2F9B760E1BAB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0948" y="1513687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4E153B8B-7DD2-9548-C266-71F29E617054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0948" y="3143298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E54A5055-6BFC-C8DF-2875-41785446A0E6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040948" y="3932380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421CDF16-A385-DE04-BCC2-3FBCC5B42FB3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09014" y="2298385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F885A902-32F4-760D-E04B-B642CE9480E0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09014" y="1513687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9AC751CA-45B0-E865-B19D-0F114C26BF4F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09014" y="3932380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85E0C00A-B969-3E62-0D11-BBFD2DF30821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209014" y="3143298"/>
            <a:ext cx="1080000" cy="70683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63" name="对象 62">
            <a:extLst>
              <a:ext uri="{FF2B5EF4-FFF2-40B4-BE49-F238E27FC236}">
                <a16:creationId xmlns:a16="http://schemas.microsoft.com/office/drawing/2014/main" id="{6994ADF9-D9DB-01A1-D5E2-496E829C672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2128315"/>
              </p:ext>
            </p:extLst>
          </p:nvPr>
        </p:nvGraphicFramePr>
        <p:xfrm>
          <a:off x="4389552" y="2190059"/>
          <a:ext cx="2249487" cy="2314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2250128" imgH="2314350" progId="Prism9.Document">
                  <p:embed/>
                </p:oleObj>
              </mc:Choice>
              <mc:Fallback>
                <p:oleObj name="Prism 9" r:id="rId16" imgW="2250128" imgH="231435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389552" y="2190059"/>
                        <a:ext cx="2249487" cy="2314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4" name="文本框 63">
            <a:extLst>
              <a:ext uri="{FF2B5EF4-FFF2-40B4-BE49-F238E27FC236}">
                <a16:creationId xmlns:a16="http://schemas.microsoft.com/office/drawing/2014/main" id="{15E2E28E-6EB8-5941-A326-7BF3FA7461C2}"/>
              </a:ext>
            </a:extLst>
          </p:cNvPr>
          <p:cNvSpPr txBox="1"/>
          <p:nvPr/>
        </p:nvSpPr>
        <p:spPr>
          <a:xfrm>
            <a:off x="145329" y="887825"/>
            <a:ext cx="774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6B9AA26-D039-00FA-4696-B2383EC603F4}"/>
              </a:ext>
            </a:extLst>
          </p:cNvPr>
          <p:cNvSpPr txBox="1"/>
          <p:nvPr/>
        </p:nvSpPr>
        <p:spPr>
          <a:xfrm>
            <a:off x="201531" y="5082121"/>
            <a:ext cx="774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0B708673-7164-50CC-FFFC-EC8860C76EFD}"/>
              </a:ext>
            </a:extLst>
          </p:cNvPr>
          <p:cNvCxnSpPr>
            <a:cxnSpLocks/>
          </p:cNvCxnSpPr>
          <p:nvPr/>
        </p:nvCxnSpPr>
        <p:spPr>
          <a:xfrm>
            <a:off x="4052028" y="4511778"/>
            <a:ext cx="13539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FFD6518C-2961-A44E-99D7-EDE2B5285AA6}"/>
              </a:ext>
            </a:extLst>
          </p:cNvPr>
          <p:cNvCxnSpPr>
            <a:cxnSpLocks/>
          </p:cNvCxnSpPr>
          <p:nvPr/>
        </p:nvCxnSpPr>
        <p:spPr>
          <a:xfrm>
            <a:off x="5204507" y="2608704"/>
            <a:ext cx="7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3">
            <a:extLst>
              <a:ext uri="{FF2B5EF4-FFF2-40B4-BE49-F238E27FC236}">
                <a16:creationId xmlns:a16="http://schemas.microsoft.com/office/drawing/2014/main" id="{3387D006-DE2C-5066-1A24-951696B66A5A}"/>
              </a:ext>
            </a:extLst>
          </p:cNvPr>
          <p:cNvSpPr txBox="1"/>
          <p:nvPr/>
        </p:nvSpPr>
        <p:spPr>
          <a:xfrm>
            <a:off x="5332268" y="241162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DA273F3-1B99-AAEA-7AD4-1BE4EB8DDF2D}"/>
              </a:ext>
            </a:extLst>
          </p:cNvPr>
          <p:cNvSpPr txBox="1"/>
          <p:nvPr/>
        </p:nvSpPr>
        <p:spPr>
          <a:xfrm>
            <a:off x="2070823" y="5725947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25E9FBE-2CD4-1FC9-207E-9AC33EA8BD11}"/>
              </a:ext>
            </a:extLst>
          </p:cNvPr>
          <p:cNvSpPr txBox="1"/>
          <p:nvPr/>
        </p:nvSpPr>
        <p:spPr>
          <a:xfrm>
            <a:off x="2580948" y="6002946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8AA3310-7685-8C78-C54A-16AA8BF8540E}"/>
              </a:ext>
            </a:extLst>
          </p:cNvPr>
          <p:cNvSpPr txBox="1"/>
          <p:nvPr/>
        </p:nvSpPr>
        <p:spPr>
          <a:xfrm>
            <a:off x="532400" y="7762182"/>
            <a:ext cx="5790332" cy="1170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, Representative IHC images and analysis of m6A level in LAUD and the adjacent normal tissues (n = 16). Scale bar, 100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B, The analysis of m6A modification level of G6PD in normal human lung epithelial cells and LUAD cells by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RIP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qPCR (n = 3). ns, no significant, *p &lt; 0.05, **p &lt; 0.01, ***p &lt; 0.001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2754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42B0638-4CD4-1D67-9A26-25A90E43081D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951" y="2534896"/>
            <a:ext cx="1440000" cy="37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22AE5E5-5286-DF89-ABCD-5B69A0ACAAAC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951" y="2969071"/>
            <a:ext cx="1440000" cy="37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08E8CDD8-D1E6-517B-7A27-428B984C611C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7694" y="2969071"/>
            <a:ext cx="1440000" cy="37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2AEE2FC-80BF-C97A-6D91-BAA132052A28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7694" y="2534895"/>
            <a:ext cx="1440000" cy="378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DEB5AFC9-DB65-F0C4-D738-48742536A79E}"/>
              </a:ext>
            </a:extLst>
          </p:cNvPr>
          <p:cNvSpPr txBox="1"/>
          <p:nvPr/>
        </p:nvSpPr>
        <p:spPr>
          <a:xfrm>
            <a:off x="1474882" y="3509694"/>
            <a:ext cx="77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C9A7B45-70C9-EE11-F002-FB811C507CA0}"/>
              </a:ext>
            </a:extLst>
          </p:cNvPr>
          <p:cNvSpPr txBox="1"/>
          <p:nvPr/>
        </p:nvSpPr>
        <p:spPr>
          <a:xfrm>
            <a:off x="4059038" y="3509694"/>
            <a:ext cx="77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9A08D09-78CC-E947-B1CD-3DEEE467F69D}"/>
              </a:ext>
            </a:extLst>
          </p:cNvPr>
          <p:cNvSpPr txBox="1"/>
          <p:nvPr/>
        </p:nvSpPr>
        <p:spPr>
          <a:xfrm rot="17816484">
            <a:off x="998214" y="1925566"/>
            <a:ext cx="1062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355D208-ACE8-2A77-D871-9DAE79E10502}"/>
              </a:ext>
            </a:extLst>
          </p:cNvPr>
          <p:cNvSpPr txBox="1"/>
          <p:nvPr/>
        </p:nvSpPr>
        <p:spPr>
          <a:xfrm rot="17816484">
            <a:off x="1365180" y="1765062"/>
            <a:ext cx="142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14-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43E6AC3-00B7-DA79-968D-2D095721CCDB}"/>
              </a:ext>
            </a:extLst>
          </p:cNvPr>
          <p:cNvSpPr txBox="1"/>
          <p:nvPr/>
        </p:nvSpPr>
        <p:spPr>
          <a:xfrm rot="17816484">
            <a:off x="1840206" y="1765062"/>
            <a:ext cx="142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14-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05BB2A0-A583-D6B9-A64B-0D6DB9E6379E}"/>
              </a:ext>
            </a:extLst>
          </p:cNvPr>
          <p:cNvSpPr txBox="1"/>
          <p:nvPr/>
        </p:nvSpPr>
        <p:spPr>
          <a:xfrm rot="17816484">
            <a:off x="3420270" y="1925566"/>
            <a:ext cx="1062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504C858-6F25-F4B9-E4F4-7CA19416DF5C}"/>
              </a:ext>
            </a:extLst>
          </p:cNvPr>
          <p:cNvSpPr txBox="1"/>
          <p:nvPr/>
        </p:nvSpPr>
        <p:spPr>
          <a:xfrm rot="17816484">
            <a:off x="3742080" y="1765062"/>
            <a:ext cx="142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14-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E053B22-7157-FA68-4C92-9C493BDD41D6}"/>
              </a:ext>
            </a:extLst>
          </p:cNvPr>
          <p:cNvSpPr txBox="1"/>
          <p:nvPr/>
        </p:nvSpPr>
        <p:spPr>
          <a:xfrm rot="17816484">
            <a:off x="4228395" y="1765062"/>
            <a:ext cx="1422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hMETTL14-2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4DA62C9-EF14-33F5-B6AB-38CE31FFA49E}"/>
              </a:ext>
            </a:extLst>
          </p:cNvPr>
          <p:cNvSpPr txBox="1"/>
          <p:nvPr/>
        </p:nvSpPr>
        <p:spPr>
          <a:xfrm>
            <a:off x="4939610" y="3019571"/>
            <a:ext cx="77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ABDD72F-A2D0-C5F5-DD5A-356DF77CC738}"/>
              </a:ext>
            </a:extLst>
          </p:cNvPr>
          <p:cNvSpPr txBox="1"/>
          <p:nvPr/>
        </p:nvSpPr>
        <p:spPr>
          <a:xfrm>
            <a:off x="4939610" y="2585395"/>
            <a:ext cx="122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9057F76-2E2D-2A31-26FD-EA74CD1FFBDB}"/>
              </a:ext>
            </a:extLst>
          </p:cNvPr>
          <p:cNvSpPr txBox="1"/>
          <p:nvPr/>
        </p:nvSpPr>
        <p:spPr>
          <a:xfrm>
            <a:off x="2565380" y="3019571"/>
            <a:ext cx="77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C8EA3C47-DEA2-D759-E294-580AE7F7B17F}"/>
              </a:ext>
            </a:extLst>
          </p:cNvPr>
          <p:cNvSpPr txBox="1"/>
          <p:nvPr/>
        </p:nvSpPr>
        <p:spPr>
          <a:xfrm>
            <a:off x="2565380" y="2585395"/>
            <a:ext cx="1226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ETTL1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BB804C0-B1AC-A205-EDD4-CFB269A407F3}"/>
              </a:ext>
            </a:extLst>
          </p:cNvPr>
          <p:cNvSpPr txBox="1"/>
          <p:nvPr/>
        </p:nvSpPr>
        <p:spPr>
          <a:xfrm>
            <a:off x="201531" y="344583"/>
            <a:ext cx="1435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D926004-148B-0A14-E313-DF5F52E4F759}"/>
              </a:ext>
            </a:extLst>
          </p:cNvPr>
          <p:cNvSpPr txBox="1"/>
          <p:nvPr/>
        </p:nvSpPr>
        <p:spPr>
          <a:xfrm>
            <a:off x="577780" y="4291508"/>
            <a:ext cx="5588070" cy="8937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wo independent shRNA sequences targeting METTL14 (shMETTL14-1 and shMETTL14-2) were separately transfected into A549 or H1299 cells. Knocking down efficiency of METTL14 in A549 or H1299 cells was confirmed by western blot.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3657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2CF0EE6-A190-D905-8601-F694B0DF9CDF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7151" y="5438591"/>
            <a:ext cx="3022101" cy="2980397"/>
          </a:xfrm>
          <a:prstGeom prst="rect">
            <a:avLst/>
          </a:prstGeom>
        </p:spPr>
      </p:pic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A8662704-1ACD-C0DA-4A05-89C677CAD0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3565608"/>
              </p:ext>
            </p:extLst>
          </p:nvPr>
        </p:nvGraphicFramePr>
        <p:xfrm>
          <a:off x="877888" y="890762"/>
          <a:ext cx="1876425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1876667" imgH="2228993" progId="Prism9.Document">
                  <p:embed/>
                </p:oleObj>
              </mc:Choice>
              <mc:Fallback>
                <p:oleObj name="Prism 9" r:id="rId3" imgW="1876667" imgH="22289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7888" y="890762"/>
                        <a:ext cx="1876425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444276C9-DDBC-A74F-0158-016560CB97E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0091355"/>
              </p:ext>
            </p:extLst>
          </p:nvPr>
        </p:nvGraphicFramePr>
        <p:xfrm>
          <a:off x="2951163" y="890762"/>
          <a:ext cx="1876425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1876667" imgH="2228993" progId="Prism9.Document">
                  <p:embed/>
                </p:oleObj>
              </mc:Choice>
              <mc:Fallback>
                <p:oleObj name="Prism 9" r:id="rId5" imgW="1876667" imgH="22289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51163" y="890762"/>
                        <a:ext cx="1876425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FB366AFB-0F7C-972E-990B-9F9EADA786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9555826"/>
              </p:ext>
            </p:extLst>
          </p:nvPr>
        </p:nvGraphicFramePr>
        <p:xfrm>
          <a:off x="904129" y="3130342"/>
          <a:ext cx="1849437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1849297" imgH="2228993" progId="Prism9.Document">
                  <p:embed/>
                </p:oleObj>
              </mc:Choice>
              <mc:Fallback>
                <p:oleObj name="Prism 9" r:id="rId7" imgW="1849297" imgH="22289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04129" y="3130342"/>
                        <a:ext cx="1849437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39C8911A-B066-FCDC-5DC1-9D80390923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4755411"/>
              </p:ext>
            </p:extLst>
          </p:nvPr>
        </p:nvGraphicFramePr>
        <p:xfrm>
          <a:off x="2753566" y="3130341"/>
          <a:ext cx="1849437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1849297" imgH="2228993" progId="Prism9.Document">
                  <p:embed/>
                </p:oleObj>
              </mc:Choice>
              <mc:Fallback>
                <p:oleObj name="Prism 9" r:id="rId9" imgW="1849297" imgH="22289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753566" y="3130341"/>
                        <a:ext cx="1849437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B7C09F91-C50E-0405-E592-9ABAFBFB8E8E}"/>
              </a:ext>
            </a:extLst>
          </p:cNvPr>
          <p:cNvSpPr txBox="1"/>
          <p:nvPr/>
        </p:nvSpPr>
        <p:spPr>
          <a:xfrm>
            <a:off x="1784389" y="729551"/>
            <a:ext cx="774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347A795-FD83-8FF2-2DAC-B2D872018F76}"/>
              </a:ext>
            </a:extLst>
          </p:cNvPr>
          <p:cNvSpPr txBox="1"/>
          <p:nvPr/>
        </p:nvSpPr>
        <p:spPr>
          <a:xfrm>
            <a:off x="3982848" y="729551"/>
            <a:ext cx="774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C711DBA-88D3-5A72-0BE9-82D1D32D508C}"/>
              </a:ext>
            </a:extLst>
          </p:cNvPr>
          <p:cNvSpPr txBox="1"/>
          <p:nvPr/>
        </p:nvSpPr>
        <p:spPr>
          <a:xfrm>
            <a:off x="1726492" y="3022232"/>
            <a:ext cx="774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2D796DD-F780-8270-9DE9-7A73412F08B2}"/>
              </a:ext>
            </a:extLst>
          </p:cNvPr>
          <p:cNvSpPr txBox="1"/>
          <p:nvPr/>
        </p:nvSpPr>
        <p:spPr>
          <a:xfrm>
            <a:off x="3924951" y="3022232"/>
            <a:ext cx="7741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26FD030-CA98-E598-2FDD-9F63EE936BCA}"/>
              </a:ext>
            </a:extLst>
          </p:cNvPr>
          <p:cNvSpPr txBox="1"/>
          <p:nvPr/>
        </p:nvSpPr>
        <p:spPr>
          <a:xfrm>
            <a:off x="201531" y="43132"/>
            <a:ext cx="1435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D2EF6E1-C7C1-CD76-B1A7-AC17E2A15D19}"/>
              </a:ext>
            </a:extLst>
          </p:cNvPr>
          <p:cNvSpPr txBox="1"/>
          <p:nvPr/>
        </p:nvSpPr>
        <p:spPr>
          <a:xfrm>
            <a:off x="558884" y="634146"/>
            <a:ext cx="774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3514909-8BA8-1236-A84B-4691D83DFCB8}"/>
              </a:ext>
            </a:extLst>
          </p:cNvPr>
          <p:cNvSpPr txBox="1"/>
          <p:nvPr/>
        </p:nvSpPr>
        <p:spPr>
          <a:xfrm>
            <a:off x="558884" y="2754169"/>
            <a:ext cx="774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3C29DEF-EE96-EDD6-9A1D-9793DF88CD6D}"/>
              </a:ext>
            </a:extLst>
          </p:cNvPr>
          <p:cNvSpPr txBox="1"/>
          <p:nvPr/>
        </p:nvSpPr>
        <p:spPr>
          <a:xfrm>
            <a:off x="558884" y="5158226"/>
            <a:ext cx="774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033643ED-744E-A5BE-EBF4-44C8BE5BF831}"/>
              </a:ext>
            </a:extLst>
          </p:cNvPr>
          <p:cNvCxnSpPr>
            <a:cxnSpLocks/>
          </p:cNvCxnSpPr>
          <p:nvPr/>
        </p:nvCxnSpPr>
        <p:spPr>
          <a:xfrm>
            <a:off x="1656228" y="152809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B800FB62-4B02-97E3-3060-C8AB2E1C72B7}"/>
              </a:ext>
            </a:extLst>
          </p:cNvPr>
          <p:cNvSpPr txBox="1"/>
          <p:nvPr/>
        </p:nvSpPr>
        <p:spPr>
          <a:xfrm>
            <a:off x="1544197" y="134588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84100B5D-64FF-9175-FA64-4EE9400D15F2}"/>
              </a:ext>
            </a:extLst>
          </p:cNvPr>
          <p:cNvCxnSpPr>
            <a:cxnSpLocks/>
          </p:cNvCxnSpPr>
          <p:nvPr/>
        </p:nvCxnSpPr>
        <p:spPr>
          <a:xfrm>
            <a:off x="1901171" y="1528094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9E275092-5655-93F0-6A73-41117FC2CE53}"/>
              </a:ext>
            </a:extLst>
          </p:cNvPr>
          <p:cNvSpPr txBox="1"/>
          <p:nvPr/>
        </p:nvSpPr>
        <p:spPr>
          <a:xfrm>
            <a:off x="2012296" y="134588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F433ECE5-C8ED-F15C-C3E9-34103BD60081}"/>
              </a:ext>
            </a:extLst>
          </p:cNvPr>
          <p:cNvCxnSpPr>
            <a:cxnSpLocks/>
          </p:cNvCxnSpPr>
          <p:nvPr/>
        </p:nvCxnSpPr>
        <p:spPr>
          <a:xfrm>
            <a:off x="3702597" y="152809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CF28B1E6-0254-596A-FF4D-FBA6585BC277}"/>
              </a:ext>
            </a:extLst>
          </p:cNvPr>
          <p:cNvSpPr txBox="1"/>
          <p:nvPr/>
        </p:nvSpPr>
        <p:spPr>
          <a:xfrm>
            <a:off x="3590566" y="134588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60D0F812-5E96-4A2F-5496-ECEA99F59AE1}"/>
              </a:ext>
            </a:extLst>
          </p:cNvPr>
          <p:cNvCxnSpPr>
            <a:cxnSpLocks/>
          </p:cNvCxnSpPr>
          <p:nvPr/>
        </p:nvCxnSpPr>
        <p:spPr>
          <a:xfrm>
            <a:off x="3947540" y="1528094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1EF655A4-682C-F799-17D4-CA94444F8C74}"/>
              </a:ext>
            </a:extLst>
          </p:cNvPr>
          <p:cNvSpPr txBox="1"/>
          <p:nvPr/>
        </p:nvSpPr>
        <p:spPr>
          <a:xfrm>
            <a:off x="4058665" y="134588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2A37198B-F5BF-99FC-87FE-4762DE16573C}"/>
              </a:ext>
            </a:extLst>
          </p:cNvPr>
          <p:cNvCxnSpPr>
            <a:cxnSpLocks/>
          </p:cNvCxnSpPr>
          <p:nvPr/>
        </p:nvCxnSpPr>
        <p:spPr>
          <a:xfrm>
            <a:off x="3502931" y="3834224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82F1EB28-2C37-D91B-3F8E-4C376A4CBEF3}"/>
              </a:ext>
            </a:extLst>
          </p:cNvPr>
          <p:cNvSpPr txBox="1"/>
          <p:nvPr/>
        </p:nvSpPr>
        <p:spPr>
          <a:xfrm>
            <a:off x="3390900" y="365201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29806226-A406-6E07-BAF2-6D37439FEFB3}"/>
              </a:ext>
            </a:extLst>
          </p:cNvPr>
          <p:cNvCxnSpPr>
            <a:cxnSpLocks/>
          </p:cNvCxnSpPr>
          <p:nvPr/>
        </p:nvCxnSpPr>
        <p:spPr>
          <a:xfrm>
            <a:off x="3747874" y="3834224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9E284066-770D-8B3E-C7B5-88658B7BD003}"/>
              </a:ext>
            </a:extLst>
          </p:cNvPr>
          <p:cNvSpPr txBox="1"/>
          <p:nvPr/>
        </p:nvSpPr>
        <p:spPr>
          <a:xfrm>
            <a:off x="3858999" y="3652014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9167F0D7-56C3-A87F-85E9-9585210B4DAC}"/>
              </a:ext>
            </a:extLst>
          </p:cNvPr>
          <p:cNvCxnSpPr>
            <a:cxnSpLocks/>
          </p:cNvCxnSpPr>
          <p:nvPr/>
        </p:nvCxnSpPr>
        <p:spPr>
          <a:xfrm>
            <a:off x="1653494" y="3705971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06145D6B-7111-E430-BA17-C540C7CA0B34}"/>
              </a:ext>
            </a:extLst>
          </p:cNvPr>
          <p:cNvSpPr txBox="1"/>
          <p:nvPr/>
        </p:nvSpPr>
        <p:spPr>
          <a:xfrm>
            <a:off x="1541463" y="3523761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91BB130C-EA01-DEAB-5B1F-1CEF45BA1448}"/>
              </a:ext>
            </a:extLst>
          </p:cNvPr>
          <p:cNvCxnSpPr>
            <a:cxnSpLocks/>
          </p:cNvCxnSpPr>
          <p:nvPr/>
        </p:nvCxnSpPr>
        <p:spPr>
          <a:xfrm>
            <a:off x="1898437" y="3705971"/>
            <a:ext cx="6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974FEA86-C828-12B0-93FF-E660E33331E8}"/>
              </a:ext>
            </a:extLst>
          </p:cNvPr>
          <p:cNvSpPr txBox="1"/>
          <p:nvPr/>
        </p:nvSpPr>
        <p:spPr>
          <a:xfrm>
            <a:off x="2009562" y="3523761"/>
            <a:ext cx="4405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B9E1431-E0A3-F0B7-5756-27B6BEAB338D}"/>
              </a:ext>
            </a:extLst>
          </p:cNvPr>
          <p:cNvSpPr txBox="1"/>
          <p:nvPr/>
        </p:nvSpPr>
        <p:spPr>
          <a:xfrm>
            <a:off x="211180" y="8377906"/>
            <a:ext cx="6151472" cy="1447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, The analysis of cell proliferation in WT and METTL14-overexpressing LUAD cells with G6PD knockdown or not (n = 5). B, The analysis of cell migration in WT and METTL14-overexpressing LUAD cells with G6PD knockdown or not (n = 5). C, Kaplan–Meier survival curve analysis of overall survival (OS) in LUAD patients with high and low G6PD mRNA level. *p &lt; 0.05, **p &lt; 0.01, ***p &lt; 0.001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4139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73</TotalTime>
  <Words>257</Words>
  <Application>Microsoft Office PowerPoint</Application>
  <PresentationFormat>A4 纸张(210x297 毫米)</PresentationFormat>
  <Paragraphs>47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主题​​</vt:lpstr>
      <vt:lpstr>Prism 9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jun</dc:creator>
  <cp:lastModifiedBy>Yanjun Zheng</cp:lastModifiedBy>
  <cp:revision>107</cp:revision>
  <dcterms:created xsi:type="dcterms:W3CDTF">2022-10-18T08:04:47Z</dcterms:created>
  <dcterms:modified xsi:type="dcterms:W3CDTF">2024-07-29T02:31:54Z</dcterms:modified>
</cp:coreProperties>
</file>